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0424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52" d="100"/>
          <a:sy n="152" d="100"/>
        </p:scale>
        <p:origin x="604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B29A51-1AA1-1089-2A22-58D47FCFB7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4187EB5-E949-7704-8663-B01D18BF1B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37EDF4-D608-5D6E-7DFB-8778358E8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16BCB4F-01D6-9FF6-3145-7718CCF2A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7D10FA-3A38-EFFF-00BE-08AA357A0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704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960CB0-6384-A007-8289-0CBC7D727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8025B8-707B-AFE4-8235-BFCC03FA59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163998-D1DD-129B-F677-033A186AC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A3F9E5-33C8-F0CB-E1C3-1CF6DF897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DFCF70-C8D1-510A-A167-5FEB4B90A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538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C1C7062-E18A-15B1-52C7-6A2E356684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C3A9F5-0B70-4B9B-31FF-A84AA4E271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30039D-766D-2C0C-5952-8BDF8B419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4D115C-A6D3-24A8-5ACF-09E14C79D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0513E6-326A-E818-35AF-77A600BBB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5209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512CC1-CCC7-F746-5F51-7F079D4562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8E363C7-BC8B-BE63-D04E-5B6BD9BAE4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B79141-4A6C-BCE3-CD7E-0F4407E7F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1DD91D-F6AD-9F83-9D9F-5748BF4D4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FB8570-8FE3-24F4-D0AE-C4671126C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527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A77423-E2BE-A73E-12C3-7B9CE4C41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65267AE-1EC9-8A91-FE84-2D77366290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127D00-4522-01C5-B349-17B237D1C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CB7271-94DF-5D20-6B80-83BC96D26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5A3AE7-B36C-84A3-C692-6B69FC145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2170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F24DD7-6694-8476-3DB1-449F48A2CA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E5E1F7-FC44-8EE9-CD0E-C4AF647EB8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206F36D-9EC9-5750-FCEC-3D6832C3E8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BFE7935-FCA9-BA60-5443-B3F6E0EC4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7894B7B-260C-D4E2-2B91-94FEF69B5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DE87340-4E30-4D52-5BBF-469389ACA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253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1AB995-E180-478A-6F93-17573BA0B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A44DB45-447F-4112-958D-AEC27539B9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E4F70D0-5253-570E-51C3-FA88964964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BFDAB4F-6510-00A2-D58A-00394D2DAE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44006F6-7E52-F7C8-E385-FFD6E42300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AF592B2-0892-D1A8-42E4-47D413D48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AEF0D90-8A1C-294E-1A88-D9969AE13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88EBE34-F33A-E32A-05F0-F53E7BE8F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187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3A5BE9-D865-94A6-3F24-17CB1CCBD6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29C3A46-DCDB-0270-F03A-56199E6E8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AC0CB3E-18A9-B1FB-873F-2CF128D24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F940779-36AD-0037-2433-39715FB86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71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441FD8B-B544-9753-5CBE-5E46D34CE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992C008-40B8-0C64-F809-C2765D5D5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DD1329C-4076-0D74-B4FA-D1A0C09F9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344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E6F306-2134-C4F0-F6EE-00C590F28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354D69-9CDC-6AF0-7FF0-174EC88259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27F77B8-A6E0-861B-E82B-064BD302F2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2F8E743-E181-9600-4151-90865A434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FA7D16-4501-E5D6-6F2E-3AA000DBA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3A210E6-ACC8-AD42-594F-011853664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8409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6465C1-97B0-1229-4F72-C9AFD0C0BD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0B86253-27DA-1A54-A337-D7B77C5DB7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CEEEBD8-3E97-0331-4AB3-BCCB94D9EB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AD3CCC-4431-9B5F-F7FA-FD807C031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E756BC5-03BE-E54D-1ED0-9FEB27C64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DB44A6-7A32-56B9-7035-91BE0E585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5840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546CB61-1D5F-FC19-406D-F0572B781F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674C362-4E82-E0D2-2075-5A5E4F8AF7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D4E648-AC80-A4DD-B0B5-5FA2D6DF77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BBE565-E6D8-BC45-B212-2CFA701CBE6B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D1A407-6EA6-0BFB-6A70-FDA2DF9318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E3BA47-F5DE-5065-A617-4013A99849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396D2D-3E21-BA45-A4F1-BEB6F0F71D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753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D473B49-C39D-7AA2-A360-8570F8FA3E7D}"/>
              </a:ext>
            </a:extLst>
          </p:cNvPr>
          <p:cNvSpPr txBox="1"/>
          <p:nvPr/>
        </p:nvSpPr>
        <p:spPr>
          <a:xfrm>
            <a:off x="9504320" y="142018"/>
            <a:ext cx="2687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.1</a:t>
            </a:r>
            <a:r>
              <a:rPr lang="ja-JP" altLang="ja-JP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649FCC3-07AC-0F61-D7C2-B448F4740FB9}"/>
              </a:ext>
            </a:extLst>
          </p:cNvPr>
          <p:cNvSpPr txBox="1"/>
          <p:nvPr/>
        </p:nvSpPr>
        <p:spPr>
          <a:xfrm>
            <a:off x="234778" y="803866"/>
            <a:ext cx="5764173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ith MBC who received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eribulin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treatment at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hinshu University Hospital between 2011 and 2022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n = 97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8911E10-7412-7BFD-59FE-B0AAD251DC07}"/>
              </a:ext>
            </a:extLst>
          </p:cNvPr>
          <p:cNvSpPr txBox="1"/>
          <p:nvPr/>
        </p:nvSpPr>
        <p:spPr>
          <a:xfrm>
            <a:off x="1640231" y="3105834"/>
            <a:ext cx="2953265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ata available for analysis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n = 67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75B696A-C66C-FB75-CD1D-0160DC401AB9}"/>
              </a:ext>
            </a:extLst>
          </p:cNvPr>
          <p:cNvSpPr txBox="1"/>
          <p:nvPr/>
        </p:nvSpPr>
        <p:spPr>
          <a:xfrm>
            <a:off x="6406724" y="1861738"/>
            <a:ext cx="5258053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ith performance status 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 (n = 2)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ith lack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ja-JP" altLang="en-US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clinical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ata (n = 28)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23FDBD9-E210-7BDB-5750-2428F71D5E5A}"/>
              </a:ext>
            </a:extLst>
          </p:cNvPr>
          <p:cNvSpPr txBox="1"/>
          <p:nvPr/>
        </p:nvSpPr>
        <p:spPr>
          <a:xfrm>
            <a:off x="1640231" y="5529480"/>
            <a:ext cx="2953265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nal analysis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n = 55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1F823D7-D3C8-04C1-9ADC-2E0C0225CECB}"/>
              </a:ext>
            </a:extLst>
          </p:cNvPr>
          <p:cNvSpPr txBox="1"/>
          <p:nvPr/>
        </p:nvSpPr>
        <p:spPr>
          <a:xfrm>
            <a:off x="6406724" y="4333164"/>
            <a:ext cx="4702000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ithout posttreatment SMI data (n = 12)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379BAC65-1BB4-3BDC-46F0-8C8B00285C24}"/>
              </a:ext>
            </a:extLst>
          </p:cNvPr>
          <p:cNvCxnSpPr>
            <a:stCxn id="5" idx="2"/>
            <a:endCxn id="10" idx="0"/>
          </p:cNvCxnSpPr>
          <p:nvPr/>
        </p:nvCxnSpPr>
        <p:spPr>
          <a:xfrm flipH="1">
            <a:off x="3116864" y="1727196"/>
            <a:ext cx="1" cy="13786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C50E6791-9A35-4FD6-5596-91F09B1A0BF7}"/>
              </a:ext>
            </a:extLst>
          </p:cNvPr>
          <p:cNvCxnSpPr>
            <a:cxnSpLocks/>
            <a:endCxn id="19" idx="0"/>
          </p:cNvCxnSpPr>
          <p:nvPr/>
        </p:nvCxnSpPr>
        <p:spPr>
          <a:xfrm>
            <a:off x="3116863" y="3752165"/>
            <a:ext cx="1" cy="17773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9E9B7A9E-05A8-E8EB-0E96-0BC0CB8CC409}"/>
              </a:ext>
            </a:extLst>
          </p:cNvPr>
          <p:cNvCxnSpPr>
            <a:cxnSpLocks/>
            <a:endCxn id="18" idx="1"/>
          </p:cNvCxnSpPr>
          <p:nvPr/>
        </p:nvCxnSpPr>
        <p:spPr>
          <a:xfrm>
            <a:off x="3116863" y="2323403"/>
            <a:ext cx="328986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DAC78494-BBFA-A789-5433-E6ED844C082F}"/>
              </a:ext>
            </a:extLst>
          </p:cNvPr>
          <p:cNvCxnSpPr/>
          <p:nvPr/>
        </p:nvCxnSpPr>
        <p:spPr>
          <a:xfrm>
            <a:off x="3116863" y="4656329"/>
            <a:ext cx="328986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35558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</TotalTime>
  <Words>74</Words>
  <Application>Microsoft Office PowerPoint</Application>
  <PresentationFormat>ワイド画面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正統 網谷</dc:creator>
  <cp:lastModifiedBy>Takaaki Oba</cp:lastModifiedBy>
  <cp:revision>10</cp:revision>
  <dcterms:created xsi:type="dcterms:W3CDTF">2025-08-26T12:46:24Z</dcterms:created>
  <dcterms:modified xsi:type="dcterms:W3CDTF">2025-09-03T10:07:54Z</dcterms:modified>
</cp:coreProperties>
</file>